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8340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83200" cy="9907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98800" y="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55680" y="742680"/>
            <a:ext cx="2571840" cy="37148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8680" y="4704840"/>
            <a:ext cx="5505480" cy="4457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0896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98800" y="940896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fld id="{E7D599C5-A54D-4458-A264-3BE0FDDA54C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2155680" y="743040"/>
            <a:ext cx="2571840" cy="371484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8680" y="4704840"/>
            <a:ext cx="5505480" cy="4457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TRIPSI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EC989-DC29-4DBC-B7D1-1AB83131C1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34757-724D-4A63-B40A-4DC41A1EFE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92940-15AF-4C87-93AB-B99D061D17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E968F-144D-4DAC-9C73-C8748CDA0A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67322-6A66-4BD6-B5B4-505748D317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03491-669D-48A1-A222-82E7EF6586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DB5E4-7119-4F02-854C-D45F9C3E3F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FE330-55F5-4743-BFFF-AB7CD92AB1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269251-3E8F-4264-83D7-C1793226BB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6F336-9496-487F-8B11-7930848A56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F15C2-4C5C-419F-83F7-0E49D8F12F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002EB-291F-4704-A679-E6D2B89897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9EABC0-4C3B-401F-BA19-D97A12C1761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2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404640" y="4952880"/>
            <a:ext cx="6297840" cy="211608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2"/>
          <a:stretch/>
        </p:blipFill>
        <p:spPr>
          <a:xfrm>
            <a:off x="390600" y="200160"/>
            <a:ext cx="6297480" cy="211608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3"/>
          <a:stretch/>
        </p:blipFill>
        <p:spPr>
          <a:xfrm>
            <a:off x="390600" y="2505240"/>
            <a:ext cx="6297480" cy="211608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3240720" y="57240"/>
            <a:ext cx="218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 [M+4H]: 996.38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3068640" y="128520"/>
            <a:ext cx="21600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032720" y="2936880"/>
            <a:ext cx="218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 [M+3H]: 773.69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3860640" y="3081240"/>
            <a:ext cx="21600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H="1">
            <a:off x="2421000" y="2792520"/>
            <a:ext cx="216000" cy="21564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639160" y="2576520"/>
            <a:ext cx="215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[M+4H]: 580.52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5000" y="42120"/>
            <a:ext cx="1578240" cy="215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45-C59; C54-C74; C65-C1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2840" y="2360160"/>
            <a:ext cx="642600" cy="215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98-C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19520" y="4807800"/>
            <a:ext cx="698760" cy="215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135-C1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5157720" y="6176880"/>
            <a:ext cx="21600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981000" y="5384880"/>
            <a:ext cx="21600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393080" y="5816520"/>
            <a:ext cx="218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 [M+3H]: 809.07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270440" y="5240160"/>
            <a:ext cx="215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[M+4H]: 607.05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3T16:34:51Z</dcterms:created>
  <dc:creator>Administrator</dc:creator>
  <dc:description/>
  <dc:language>en-US</dc:language>
  <cp:lastModifiedBy>Daniel Maragno Trindade</cp:lastModifiedBy>
  <dcterms:modified xsi:type="dcterms:W3CDTF">2009-03-17T11:46:28Z</dcterms:modified>
  <cp:revision>10</cp:revision>
  <dc:subject/>
  <dc:title>Slide 1</dc:title>
</cp:coreProperties>
</file>